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7D7C6C-1CB9-41BD-989B-350CD077240A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8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it-IT" sz="1200" spc="-1" strike="noStrike">
              <a:solidFill>
                <a:srgbClr val="ff0000"/>
              </a:solidFill>
              <a:latin typeface="Calibri"/>
            </a:endParaRPr>
          </a:p>
        </p:txBody>
      </p:sp>
      <p:sp>
        <p:nvSpPr>
          <p:cNvPr id="87" name="Segnaposto numero diapositiva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F1B0B6-1FD6-4877-BD6D-C52C7FC996ED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2A5EB8-CB65-4BDA-8852-0AF75915987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EE61D9-78E7-42D0-B7BD-2B50283ACE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479853-3628-4ECA-9CCE-5487DDF8301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5617DC-2305-4A4D-A305-93C31E813C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0FD021-22B6-4A9E-905B-0B93D06909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BDFF61-A80D-459C-BDD8-C8337CC3CB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CA9EEB-F326-4771-8F81-D1CEA2C17E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F07836-473D-48A6-A36C-E20FC5C269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02CDFC-E306-4FDB-BD66-BDCB0068DB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4B9291-75A2-4351-9C64-F19AB397AB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209319-7423-48D0-A5FE-611C74C9D9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E2214D-7304-4B2A-B23A-55597DAF86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4A61DC2-E501-475A-9313-A65EB8E57B77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5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8" descr=""/>
          <p:cNvPicPr/>
          <p:nvPr/>
        </p:nvPicPr>
        <p:blipFill>
          <a:blip r:embed="rId1">
            <a:grayscl/>
          </a:blip>
          <a:srcRect l="17263" t="0" r="0" b="0"/>
          <a:stretch/>
        </p:blipFill>
        <p:spPr>
          <a:xfrm>
            <a:off x="4351320" y="4716360"/>
            <a:ext cx="1440000" cy="782640"/>
          </a:xfrm>
          <a:prstGeom prst="rect">
            <a:avLst/>
          </a:prstGeom>
          <a:ln w="0">
            <a:noFill/>
          </a:ln>
        </p:spPr>
      </p:pic>
      <p:sp>
        <p:nvSpPr>
          <p:cNvPr id="49" name="CasellaDiTesto 36"/>
          <p:cNvSpPr/>
          <p:nvPr/>
        </p:nvSpPr>
        <p:spPr>
          <a:xfrm>
            <a:off x="4253040" y="6243480"/>
            <a:ext cx="16970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.    </a:t>
            </a: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KHep1C3 72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.   </a:t>
            </a: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ipofectamine 72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.    </a:t>
            </a: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ti-miR-193a 50 nM 72h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.   </a:t>
            </a: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ti-miR- 193a 100 nM 72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CasellaDiTesto 37"/>
          <p:cNvSpPr/>
          <p:nvPr/>
        </p:nvSpPr>
        <p:spPr>
          <a:xfrm>
            <a:off x="4253040" y="5724360"/>
            <a:ext cx="16970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KHep1C3 48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ipofectamine 48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ti-miR-193a 50 nM 48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ti-miR-193a 100 nM 48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CasellaDiTesto 39"/>
          <p:cNvSpPr/>
          <p:nvPr/>
        </p:nvSpPr>
        <p:spPr>
          <a:xfrm>
            <a:off x="1319040" y="5931000"/>
            <a:ext cx="1695600" cy="143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ipofectamine 48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 nM miR-193a 48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 nM miR-193a 48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KHep1C3 72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ipofectamine  72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 nM miR-193a 72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 nM miR-193a 72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CasellaDiTesto 18"/>
          <p:cNvSpPr/>
          <p:nvPr/>
        </p:nvSpPr>
        <p:spPr>
          <a:xfrm>
            <a:off x="1362240" y="5796000"/>
            <a:ext cx="192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228600" indent="-228600">
              <a:lnSpc>
                <a:spcPct val="100000"/>
              </a:lnSpc>
              <a:buClr>
                <a:srgbClr val="000000"/>
              </a:buClr>
              <a:buFont typeface="Times New Roman"/>
              <a:buAutoNum type="arabicPlain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      3       4     5     6    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CasellaDiTesto 18"/>
          <p:cNvSpPr/>
          <p:nvPr/>
        </p:nvSpPr>
        <p:spPr>
          <a:xfrm>
            <a:off x="4340160" y="5465880"/>
            <a:ext cx="189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228600" indent="-228600">
              <a:lnSpc>
                <a:spcPct val="100000"/>
              </a:lnSpc>
              <a:buClr>
                <a:srgbClr val="000000"/>
              </a:buClr>
              <a:buFont typeface="Times New Roman"/>
              <a:buAutoNum type="arabicPlain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     3     4     5     6     7    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CasellaDiTesto 42"/>
          <p:cNvSpPr/>
          <p:nvPr/>
        </p:nvSpPr>
        <p:spPr>
          <a:xfrm>
            <a:off x="1341360" y="4346640"/>
            <a:ext cx="1656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ading control (Coomassie staining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CasellaDiTesto 43"/>
          <p:cNvSpPr/>
          <p:nvPr/>
        </p:nvSpPr>
        <p:spPr>
          <a:xfrm>
            <a:off x="4251240" y="4335480"/>
            <a:ext cx="1656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ading control (Coomassie staining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ttangolo 46"/>
          <p:cNvSpPr/>
          <p:nvPr/>
        </p:nvSpPr>
        <p:spPr>
          <a:xfrm>
            <a:off x="765000" y="4067280"/>
            <a:ext cx="5759640" cy="3025800"/>
          </a:xfrm>
          <a:prstGeom prst="rect">
            <a:avLst/>
          </a:prstGeom>
          <a:noFill/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CasellaDiTesto 48"/>
          <p:cNvSpPr/>
          <p:nvPr/>
        </p:nvSpPr>
        <p:spPr>
          <a:xfrm>
            <a:off x="836640" y="4067280"/>
            <a:ext cx="180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KHep1C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CasellaDiTesto 28"/>
          <p:cNvSpPr/>
          <p:nvPr/>
        </p:nvSpPr>
        <p:spPr>
          <a:xfrm>
            <a:off x="5181480" y="2011320"/>
            <a:ext cx="1695600" cy="84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</a:t>
            </a:r>
            <a:r>
              <a:rPr b="0" lang="it-IT" sz="8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72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.   HA22T/VGH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.   Lipofectamin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.  50 nM  anti-miR-193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.  100 nM  anti-miR-193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CasellaDiTesto 29"/>
          <p:cNvSpPr/>
          <p:nvPr/>
        </p:nvSpPr>
        <p:spPr>
          <a:xfrm>
            <a:off x="3741840" y="2023920"/>
            <a:ext cx="1697040" cy="71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</a:t>
            </a:r>
            <a:r>
              <a:rPr b="0" lang="it-IT" sz="8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48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A22T/VG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ipofectamin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 nM anti-miR-193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 nM anti-miR-193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CasellaDiTesto 33"/>
          <p:cNvSpPr/>
          <p:nvPr/>
        </p:nvSpPr>
        <p:spPr>
          <a:xfrm>
            <a:off x="3693960" y="1763640"/>
            <a:ext cx="1651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     2      3      4     5    6       7      8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CasellaDiTesto 33"/>
          <p:cNvSpPr/>
          <p:nvPr/>
        </p:nvSpPr>
        <p:spPr>
          <a:xfrm>
            <a:off x="1484280" y="2935440"/>
            <a:ext cx="1697040" cy="94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A22T/VG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ipofectamin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 nM miR-193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 nM miR-193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CasellaDiTesto 20"/>
          <p:cNvSpPr/>
          <p:nvPr/>
        </p:nvSpPr>
        <p:spPr>
          <a:xfrm>
            <a:off x="1620720" y="934920"/>
            <a:ext cx="100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8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CasellaDiTesto 21"/>
          <p:cNvSpPr/>
          <p:nvPr/>
        </p:nvSpPr>
        <p:spPr>
          <a:xfrm>
            <a:off x="1628640" y="2124000"/>
            <a:ext cx="100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2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CasellaDiTesto 31"/>
          <p:cNvSpPr/>
          <p:nvPr/>
        </p:nvSpPr>
        <p:spPr>
          <a:xfrm>
            <a:off x="1287360" y="1825560"/>
            <a:ext cx="127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         2         3          4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CasellaDiTesto 44"/>
          <p:cNvSpPr/>
          <p:nvPr/>
        </p:nvSpPr>
        <p:spPr>
          <a:xfrm>
            <a:off x="1260360" y="561960"/>
            <a:ext cx="2880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ading contro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Coomassie staining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CasellaDiTesto 45"/>
          <p:cNvSpPr/>
          <p:nvPr/>
        </p:nvSpPr>
        <p:spPr>
          <a:xfrm>
            <a:off x="3860640" y="539640"/>
            <a:ext cx="3024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ading contro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omassie staining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ttangolo 43"/>
          <p:cNvSpPr/>
          <p:nvPr/>
        </p:nvSpPr>
        <p:spPr>
          <a:xfrm>
            <a:off x="765000" y="250920"/>
            <a:ext cx="5759640" cy="3529080"/>
          </a:xfrm>
          <a:prstGeom prst="rect">
            <a:avLst/>
          </a:prstGeom>
          <a:noFill/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CasellaDiTesto 49"/>
          <p:cNvSpPr/>
          <p:nvPr/>
        </p:nvSpPr>
        <p:spPr>
          <a:xfrm>
            <a:off x="765000" y="236520"/>
            <a:ext cx="180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A22T/VG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Picture 28" descr=""/>
          <p:cNvPicPr/>
          <p:nvPr/>
        </p:nvPicPr>
        <p:blipFill>
          <a:blip r:embed="rId2">
            <a:grayscl/>
          </a:blip>
          <a:stretch/>
        </p:blipFill>
        <p:spPr>
          <a:xfrm>
            <a:off x="1341360" y="1116000"/>
            <a:ext cx="1062000" cy="71928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29" descr=""/>
          <p:cNvPicPr/>
          <p:nvPr/>
        </p:nvPicPr>
        <p:blipFill>
          <a:blip r:embed="rId3">
            <a:grayscl/>
            <a:lum bright="-10000"/>
          </a:blip>
          <a:stretch/>
        </p:blipFill>
        <p:spPr>
          <a:xfrm>
            <a:off x="1341360" y="2311560"/>
            <a:ext cx="1082880" cy="71892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30" descr=""/>
          <p:cNvPicPr/>
          <p:nvPr/>
        </p:nvPicPr>
        <p:blipFill>
          <a:blip r:embed="rId4">
            <a:grayscl/>
          </a:blip>
          <a:stretch/>
        </p:blipFill>
        <p:spPr>
          <a:xfrm>
            <a:off x="3789360" y="1042920"/>
            <a:ext cx="1461960" cy="720720"/>
          </a:xfrm>
          <a:prstGeom prst="rect">
            <a:avLst/>
          </a:prstGeom>
          <a:ln w="0">
            <a:noFill/>
          </a:ln>
        </p:spPr>
      </p:pic>
      <p:grpSp>
        <p:nvGrpSpPr>
          <p:cNvPr id="72" name="Gruppo 49"/>
          <p:cNvGrpSpPr/>
          <p:nvPr/>
        </p:nvGrpSpPr>
        <p:grpSpPr>
          <a:xfrm>
            <a:off x="1413000" y="4724280"/>
            <a:ext cx="1357200" cy="1071720"/>
            <a:chOff x="1413000" y="4724280"/>
            <a:chExt cx="1357200" cy="1071720"/>
          </a:xfrm>
        </p:grpSpPr>
        <p:pic>
          <p:nvPicPr>
            <p:cNvPr id="73" name="Picture 9" descr=""/>
            <p:cNvPicPr/>
            <p:nvPr/>
          </p:nvPicPr>
          <p:blipFill>
            <a:blip r:embed="rId5">
              <a:grayscl/>
            </a:blip>
            <a:srcRect l="17931" t="0" r="49003" b="0"/>
            <a:stretch/>
          </p:blipFill>
          <p:spPr>
            <a:xfrm>
              <a:off x="1413000" y="4724280"/>
              <a:ext cx="609480" cy="1071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Picture 9" descr=""/>
            <p:cNvPicPr/>
            <p:nvPr/>
          </p:nvPicPr>
          <p:blipFill>
            <a:blip r:embed="rId6">
              <a:grayscl/>
            </a:blip>
            <a:srcRect l="58565" t="201" r="0" b="0"/>
            <a:stretch/>
          </p:blipFill>
          <p:spPr>
            <a:xfrm>
              <a:off x="2006640" y="4725720"/>
              <a:ext cx="763560" cy="10695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5" name="CasellaDiTesto 24"/>
          <p:cNvSpPr/>
          <p:nvPr/>
        </p:nvSpPr>
        <p:spPr>
          <a:xfrm>
            <a:off x="5157720" y="8615520"/>
            <a:ext cx="194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Book Antiqua"/>
              </a:rPr>
              <a:t>Additional file 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CasellaDiTesto 30"/>
          <p:cNvSpPr/>
          <p:nvPr/>
        </p:nvSpPr>
        <p:spPr>
          <a:xfrm>
            <a:off x="957240" y="933480"/>
            <a:ext cx="725400" cy="9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0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0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  -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CasellaDiTesto 34"/>
          <p:cNvSpPr/>
          <p:nvPr/>
        </p:nvSpPr>
        <p:spPr>
          <a:xfrm>
            <a:off x="1025640" y="4586400"/>
            <a:ext cx="725400" cy="125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0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Times New Roman"/>
              <a:buAutoNum type="arabicPlain" startAt="60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Times New Roman"/>
              <a:buAutoNum type="arabicPlain" startAt="60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Times New Roman"/>
              <a:buAutoNum type="arabicPlain" startAt="60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Times New Roman"/>
              <a:buAutoNum type="arabicPlain" startAt="60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Times New Roman"/>
              <a:buAutoNum type="arabicPlain" startAt="60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 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 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 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CasellaDiTesto 35"/>
          <p:cNvSpPr/>
          <p:nvPr/>
        </p:nvSpPr>
        <p:spPr>
          <a:xfrm>
            <a:off x="3976560" y="4595760"/>
            <a:ext cx="725760" cy="11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0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0 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Times New Roman"/>
              <a:buAutoNum type="arabicPlain" startAt="60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Times New Roman"/>
              <a:buAutoNum type="arabicPlain" startAt="60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Times New Roman"/>
              <a:buAutoNum type="arabicPlain" startAt="60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Times New Roman"/>
              <a:buAutoNum type="arabicPlain" startAt="60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 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CasellaDiTesto 31"/>
          <p:cNvSpPr/>
          <p:nvPr/>
        </p:nvSpPr>
        <p:spPr>
          <a:xfrm>
            <a:off x="1287360" y="2997360"/>
            <a:ext cx="127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         2         3          4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CasellaDiTesto 30"/>
          <p:cNvSpPr/>
          <p:nvPr/>
        </p:nvSpPr>
        <p:spPr>
          <a:xfrm>
            <a:off x="960480" y="2111400"/>
            <a:ext cx="725400" cy="9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0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0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  -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CasellaDiTesto 30"/>
          <p:cNvSpPr/>
          <p:nvPr/>
        </p:nvSpPr>
        <p:spPr>
          <a:xfrm>
            <a:off x="3414600" y="790560"/>
            <a:ext cx="725760" cy="9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0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0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  -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CasellaDiTesto 42"/>
          <p:cNvSpPr/>
          <p:nvPr/>
        </p:nvSpPr>
        <p:spPr>
          <a:xfrm>
            <a:off x="404640" y="179280"/>
            <a:ext cx="21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CasellaDiTesto 44"/>
          <p:cNvSpPr/>
          <p:nvPr/>
        </p:nvSpPr>
        <p:spPr>
          <a:xfrm>
            <a:off x="404640" y="3976560"/>
            <a:ext cx="21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CasellaDiTesto 45"/>
          <p:cNvSpPr/>
          <p:nvPr/>
        </p:nvSpPr>
        <p:spPr>
          <a:xfrm>
            <a:off x="692280" y="7236000"/>
            <a:ext cx="576108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Book Antiqua"/>
              </a:rPr>
              <a:t>Loading controls relative to Figs. 2A, 2B, 3A and 3B. Coomassie staining of proteins loaded on polyacrylamide gels 8% (panel A, left) and 4-12% pre-cast gels  (panel A, right and panel B). The staining highlights constant amounts of total proteins loaded for  each gel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23T12:36:47Z</dcterms:created>
  <dc:creator>salvi</dc:creator>
  <dc:description/>
  <dc:language>en-US</dc:language>
  <cp:lastModifiedBy>De Petro</cp:lastModifiedBy>
  <dcterms:modified xsi:type="dcterms:W3CDTF">2013-09-24T16:42:28Z</dcterms:modified>
  <cp:revision>63</cp:revision>
  <dc:subject/>
  <dc:title>Diapositiva 1</dc:title>
</cp:coreProperties>
</file>